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A3991-A92C-4223-8F37-745750B298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CD1C9-507F-4CFB-BC90-EFCDBFE9A9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0597A-DFAA-4C6C-ADFE-BC05324786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E3DA9-9C25-4E6F-8169-D86DFB095E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45826-BB22-47E9-80FD-340AB4D914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8B45C-79E1-468C-903A-F3916605B2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A71BD-EAC9-423A-8F22-0FA79A11D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441C0-1BDA-48AB-AA88-666BB5B7E7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5F3BD-0D11-4460-B765-DDA4BE7673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A60B4-FF8F-4E2F-8F06-C2205EE62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062B4-227A-4945-839D-F477D53806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8F9530-FE5E-4905-AF4C-8639FE7BBA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D6E42B-FB4B-457D-A40D-D48B69D003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87240" y="152280"/>
            <a:ext cx="5027760" cy="6248520"/>
            <a:chOff x="687240" y="152280"/>
            <a:chExt cx="5027760" cy="6248520"/>
          </a:xfrm>
        </p:grpSpPr>
        <p:grpSp>
          <p:nvGrpSpPr>
            <p:cNvPr id="42" name=""/>
            <p:cNvGrpSpPr/>
            <p:nvPr/>
          </p:nvGrpSpPr>
          <p:grpSpPr>
            <a:xfrm>
              <a:off x="1066680" y="152280"/>
              <a:ext cx="4429080" cy="1663560"/>
              <a:chOff x="1066680" y="152280"/>
              <a:chExt cx="4429080" cy="166356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066680" y="152280"/>
                <a:ext cx="4343400" cy="1578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1525680" y="152280"/>
                <a:ext cx="610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Notch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"/>
              <p:cNvGrpSpPr/>
              <p:nvPr/>
            </p:nvGrpSpPr>
            <p:grpSpPr>
              <a:xfrm>
                <a:off x="4724280" y="1542960"/>
                <a:ext cx="531720" cy="61920"/>
                <a:chOff x="4724280" y="1542960"/>
                <a:chExt cx="531720" cy="61920"/>
              </a:xfrm>
            </p:grpSpPr>
            <p:sp>
              <p:nvSpPr>
                <p:cNvPr id="46" name=""/>
                <p:cNvSpPr/>
                <p:nvPr/>
              </p:nvSpPr>
              <p:spPr>
                <a:xfrm>
                  <a:off x="4724280" y="1604880"/>
                  <a:ext cx="529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4724280" y="154296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5256000" y="154296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" name=""/>
              <p:cNvGrpSpPr/>
              <p:nvPr/>
            </p:nvGrpSpPr>
            <p:grpSpPr>
              <a:xfrm>
                <a:off x="1676160" y="1552680"/>
                <a:ext cx="1261440" cy="61920"/>
                <a:chOff x="1676160" y="1552680"/>
                <a:chExt cx="1261440" cy="61920"/>
              </a:xfrm>
            </p:grpSpPr>
            <p:sp>
              <p:nvSpPr>
                <p:cNvPr id="50" name=""/>
                <p:cNvSpPr/>
                <p:nvPr/>
              </p:nvSpPr>
              <p:spPr>
                <a:xfrm>
                  <a:off x="1676160" y="1614600"/>
                  <a:ext cx="1257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1676160" y="155268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2937600" y="155268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" name=""/>
              <p:cNvGrpSpPr/>
              <p:nvPr/>
            </p:nvGrpSpPr>
            <p:grpSpPr>
              <a:xfrm>
                <a:off x="3200040" y="1542960"/>
                <a:ext cx="1261440" cy="61920"/>
                <a:chOff x="3200040" y="1542960"/>
                <a:chExt cx="1261440" cy="61920"/>
              </a:xfrm>
            </p:grpSpPr>
            <p:sp>
              <p:nvSpPr>
                <p:cNvPr id="54" name=""/>
                <p:cNvSpPr/>
                <p:nvPr/>
              </p:nvSpPr>
              <p:spPr>
                <a:xfrm>
                  <a:off x="3200040" y="1604880"/>
                  <a:ext cx="1257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3200040" y="154296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4461480" y="1542960"/>
                  <a:ext cx="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7" name=""/>
              <p:cNvSpPr/>
              <p:nvPr/>
            </p:nvSpPr>
            <p:spPr>
              <a:xfrm>
                <a:off x="1753560" y="1600200"/>
                <a:ext cx="999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artial 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506760" y="1600200"/>
                <a:ext cx="68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496760" y="1600200"/>
                <a:ext cx="999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artial 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"/>
            <p:cNvSpPr/>
            <p:nvPr/>
          </p:nvSpPr>
          <p:spPr>
            <a:xfrm>
              <a:off x="839520" y="15228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61760" y="1600200"/>
              <a:ext cx="330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87240" y="32767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" name=""/>
            <p:cNvGrpSpPr/>
            <p:nvPr/>
          </p:nvGrpSpPr>
          <p:grpSpPr>
            <a:xfrm>
              <a:off x="990360" y="1752480"/>
              <a:ext cx="4486320" cy="1646280"/>
              <a:chOff x="990360" y="1752480"/>
              <a:chExt cx="4486320" cy="1646280"/>
            </a:xfrm>
          </p:grpSpPr>
          <p:pic>
            <p:nvPicPr>
              <p:cNvPr id="64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990360" y="1752480"/>
                <a:ext cx="4486320" cy="155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>
                <a:off x="1504800" y="182520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es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828800" y="3181680"/>
                <a:ext cx="84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Un-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7" name=""/>
              <p:cNvGrpSpPr/>
              <p:nvPr/>
            </p:nvGrpSpPr>
            <p:grpSpPr>
              <a:xfrm>
                <a:off x="1576440" y="3136320"/>
                <a:ext cx="1297800" cy="59040"/>
                <a:chOff x="1576440" y="3136320"/>
                <a:chExt cx="1297800" cy="59040"/>
              </a:xfrm>
            </p:grpSpPr>
            <p:sp>
              <p:nvSpPr>
                <p:cNvPr id="68" name=""/>
                <p:cNvSpPr/>
                <p:nvPr/>
              </p:nvSpPr>
              <p:spPr>
                <a:xfrm>
                  <a:off x="1576440" y="3195360"/>
                  <a:ext cx="12934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157644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287424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" name=""/>
              <p:cNvGrpSpPr/>
              <p:nvPr/>
            </p:nvGrpSpPr>
            <p:grpSpPr>
              <a:xfrm>
                <a:off x="3186000" y="3136320"/>
                <a:ext cx="511200" cy="59040"/>
                <a:chOff x="3186000" y="3136320"/>
                <a:chExt cx="511200" cy="5904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3186000" y="3195360"/>
                  <a:ext cx="509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318600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369720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5" name=""/>
              <p:cNvGrpSpPr/>
              <p:nvPr/>
            </p:nvGrpSpPr>
            <p:grpSpPr>
              <a:xfrm>
                <a:off x="3981240" y="3136320"/>
                <a:ext cx="511200" cy="59040"/>
                <a:chOff x="3981240" y="3136320"/>
                <a:chExt cx="511200" cy="59040"/>
              </a:xfrm>
            </p:grpSpPr>
            <p:sp>
              <p:nvSpPr>
                <p:cNvPr id="76" name=""/>
                <p:cNvSpPr/>
                <p:nvPr/>
              </p:nvSpPr>
              <p:spPr>
                <a:xfrm>
                  <a:off x="3981240" y="3195360"/>
                  <a:ext cx="509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398124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449244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9" name=""/>
              <p:cNvGrpSpPr/>
              <p:nvPr/>
            </p:nvGrpSpPr>
            <p:grpSpPr>
              <a:xfrm>
                <a:off x="4776840" y="3136320"/>
                <a:ext cx="510840" cy="59040"/>
                <a:chOff x="4776840" y="3136320"/>
                <a:chExt cx="510840" cy="59040"/>
              </a:xfrm>
            </p:grpSpPr>
            <p:sp>
              <p:nvSpPr>
                <p:cNvPr id="80" name=""/>
                <p:cNvSpPr/>
                <p:nvPr/>
              </p:nvSpPr>
              <p:spPr>
                <a:xfrm>
                  <a:off x="4776840" y="3195360"/>
                  <a:ext cx="509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477684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5287680" y="3136320"/>
                  <a:ext cx="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" name=""/>
              <p:cNvSpPr/>
              <p:nvPr/>
            </p:nvSpPr>
            <p:spPr>
              <a:xfrm>
                <a:off x="3125880" y="3183120"/>
                <a:ext cx="68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3811680" y="3183120"/>
                <a:ext cx="84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Un-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4686120" y="3183120"/>
                <a:ext cx="68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ethyl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6" name=""/>
            <p:cNvGrpSpPr/>
            <p:nvPr/>
          </p:nvGrpSpPr>
          <p:grpSpPr>
            <a:xfrm>
              <a:off x="990360" y="3352680"/>
              <a:ext cx="4343400" cy="1628640"/>
              <a:chOff x="990360" y="3352680"/>
              <a:chExt cx="4343400" cy="1628640"/>
            </a:xfrm>
          </p:grpSpPr>
          <p:pic>
            <p:nvPicPr>
              <p:cNvPr id="87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990360" y="3352680"/>
                <a:ext cx="4343400" cy="1628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" name=""/>
              <p:cNvSpPr/>
              <p:nvPr/>
            </p:nvSpPr>
            <p:spPr>
              <a:xfrm>
                <a:off x="1753920" y="3503520"/>
                <a:ext cx="47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Hes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"/>
            <p:cNvGrpSpPr/>
            <p:nvPr/>
          </p:nvGrpSpPr>
          <p:grpSpPr>
            <a:xfrm>
              <a:off x="990360" y="4876920"/>
              <a:ext cx="4724640" cy="1523880"/>
              <a:chOff x="990360" y="4876920"/>
              <a:chExt cx="4724640" cy="1523880"/>
            </a:xfrm>
          </p:grpSpPr>
          <p:pic>
            <p:nvPicPr>
              <p:cNvPr id="90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990360" y="4876920"/>
                <a:ext cx="4724640" cy="1523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"/>
              <p:cNvSpPr/>
              <p:nvPr/>
            </p:nvSpPr>
            <p:spPr>
              <a:xfrm>
                <a:off x="1646280" y="4978440"/>
                <a:ext cx="47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Hes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" name=""/>
            <p:cNvSpPr/>
            <p:nvPr/>
          </p:nvSpPr>
          <p:spPr>
            <a:xfrm>
              <a:off x="687240" y="46483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"/>
          <p:cNvSpPr/>
          <p:nvPr/>
        </p:nvSpPr>
        <p:spPr>
          <a:xfrm>
            <a:off x="5791320" y="1600200"/>
            <a:ext cx="312408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2. Notch3, Hes4, Hes2 and Hes6 expression levels in various leukemia cell line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 leukemia cells were either untreated, or treated with 5-aza-2’-deoxycytidine (DAC) only, suberoylanilide hydroxamic acid (SAHA) only or both (D+S) as described in material and methods. Real-time PCR analysis. In general, expression of Notch3 and Hes4 was restored in some leukemia cell lines treated by DAC with or without SAHA. Hes2 was un-respond to any DAC, and SAHA treatment. In contrast, Hes6 was respond to DAC, and SAHA treatme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01:58:31Z</dcterms:created>
  <dc:creator>SKuang</dc:creator>
  <dc:description/>
  <dc:language>en-US</dc:language>
  <cp:lastModifiedBy>jpilab</cp:lastModifiedBy>
  <dcterms:modified xsi:type="dcterms:W3CDTF">2009-03-29T03:51:01Z</dcterms:modified>
  <cp:revision>69</cp:revision>
  <dc:subject/>
  <dc:title>Slide 1</dc:title>
</cp:coreProperties>
</file>